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85170" autoAdjust="0"/>
  </p:normalViewPr>
  <p:slideViewPr>
    <p:cSldViewPr snapToGrid="0">
      <p:cViewPr varScale="1">
        <p:scale>
          <a:sx n="73" d="100"/>
          <a:sy n="73" d="100"/>
        </p:scale>
        <p:origin x="32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D74018-0958-E242-B490-40865DD4A67B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E21303-FCC0-FA49-A652-A40D2B58A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743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080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539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6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048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90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69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384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41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50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16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061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E5A7B5-5575-41A7-8E76-F5B9EE3B6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7110" y="213571"/>
            <a:ext cx="5915025" cy="1767417"/>
          </a:xfrm>
        </p:spPr>
        <p:txBody>
          <a:bodyPr>
            <a:norm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Kaplan Meier curves in MIBC cohort </a:t>
            </a:r>
            <a:b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Overall Survival and B) Relapse Free Survival (RFS)</a:t>
            </a:r>
            <a:br>
              <a:rPr lang="en-US" sz="1600" b="1" dirty="0"/>
            </a:br>
            <a:r>
              <a:rPr lang="en-US" sz="1600" dirty="0"/>
              <a:t> </a:t>
            </a:r>
            <a:br>
              <a:rPr lang="en-US" dirty="0"/>
            </a:br>
            <a:endParaRPr lang="en-US" dirty="0"/>
          </a:p>
        </p:txBody>
      </p:sp>
      <p:pic>
        <p:nvPicPr>
          <p:cNvPr id="6" name="Picture 5" descr="A graph of a number of patients&#10;&#10;Description automatically generated">
            <a:extLst>
              <a:ext uri="{FF2B5EF4-FFF2-40B4-BE49-F238E27FC236}">
                <a16:creationId xmlns:a16="http://schemas.microsoft.com/office/drawing/2014/main" id="{BF643D13-D090-46DB-885B-218423AAD4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5865" y="1097280"/>
            <a:ext cx="5313368" cy="75043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2527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44</TotalTime>
  <Words>27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ry Figure 2: Kaplan Meier curves in MIBC cohort  A) Overall Survival and B) Relapse Free Survival (RFS)  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Duan</dc:creator>
  <cp:lastModifiedBy>Campbell,Matthew</cp:lastModifiedBy>
  <cp:revision>24</cp:revision>
  <dcterms:created xsi:type="dcterms:W3CDTF">2023-03-30T22:39:16Z</dcterms:created>
  <dcterms:modified xsi:type="dcterms:W3CDTF">2024-06-26T14:29:02Z</dcterms:modified>
</cp:coreProperties>
</file>